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7F91F7C0-9D51-FB3D-2DA5-AF7D44311C3D}" name="Chris White-Gloria" initials="CW" userId="S::christopher.whiteglo@ucalgary.ca::12b20c24-b684-4e3b-aa73-22712dbab8c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5E11FBE-71E5-ECAB-4970-20DB22274786}" v="2" dt="2025-07-21T19:02:43.653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0612"/>
  </p:normalViewPr>
  <p:slideViewPr>
    <p:cSldViewPr snapToGrid="0">
      <p:cViewPr varScale="1">
        <p:scale>
          <a:sx n="115" d="100"/>
          <a:sy n="115" d="100"/>
        </p:scale>
        <p:origin x="101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 White-Gloria" userId="S::christopher.whiteglo@ucalgary.ca::12b20c24-b684-4e3b-aa73-22712dbab8ca" providerId="AD" clId="Web-{65E11FBE-71E5-ECAB-4970-20DB22274786}"/>
    <pc:docChg chg="delSld">
      <pc:chgData name="Chris White-Gloria" userId="S::christopher.whiteglo@ucalgary.ca::12b20c24-b684-4e3b-aa73-22712dbab8ca" providerId="AD" clId="Web-{65E11FBE-71E5-ECAB-4970-20DB22274786}" dt="2025-07-21T19:02:39.138" v="0"/>
      <pc:docMkLst>
        <pc:docMk/>
      </pc:docMkLst>
      <pc:sldChg chg="del">
        <pc:chgData name="Chris White-Gloria" userId="S::christopher.whiteglo@ucalgary.ca::12b20c24-b684-4e3b-aa73-22712dbab8ca" providerId="AD" clId="Web-{65E11FBE-71E5-ECAB-4970-20DB22274786}" dt="2025-07-21T19:02:39.138" v="0"/>
        <pc:sldMkLst>
          <pc:docMk/>
          <pc:sldMk cId="4195218696" sldId="256"/>
        </pc:sldMkLst>
      </pc:sldChg>
    </pc:docChg>
  </pc:docChgLst>
  <pc:docChgLst>
    <pc:chgData name="Adriana Zardini Buzatto" userId="209ab1e5-b9cf-48a9-944f-50524a000cca" providerId="ADAL" clId="{C9E12019-426E-43D5-9999-0BE2D9E356F9}"/>
    <pc:docChg chg="modSld">
      <pc:chgData name="Adriana Zardini Buzatto" userId="209ab1e5-b9cf-48a9-944f-50524a000cca" providerId="ADAL" clId="{C9E12019-426E-43D5-9999-0BE2D9E356F9}" dt="2025-07-21T18:43:32.935" v="11" actId="20577"/>
      <pc:docMkLst>
        <pc:docMk/>
      </pc:docMkLst>
      <pc:sldChg chg="modSp mod">
        <pc:chgData name="Adriana Zardini Buzatto" userId="209ab1e5-b9cf-48a9-944f-50524a000cca" providerId="ADAL" clId="{C9E12019-426E-43D5-9999-0BE2D9E356F9}" dt="2025-07-21T18:43:32.935" v="11" actId="20577"/>
        <pc:sldMkLst>
          <pc:docMk/>
          <pc:sldMk cId="2349094421" sldId="259"/>
        </pc:sldMkLst>
        <pc:graphicFrameChg chg="modGraphic">
          <ac:chgData name="Adriana Zardini Buzatto" userId="209ab1e5-b9cf-48a9-944f-50524a000cca" providerId="ADAL" clId="{C9E12019-426E-43D5-9999-0BE2D9E356F9}" dt="2025-07-21T18:43:32.935" v="11" actId="20577"/>
          <ac:graphicFrameMkLst>
            <pc:docMk/>
            <pc:sldMk cId="2349094421" sldId="259"/>
            <ac:graphicFrameMk id="3" creationId="{FB01BE41-0DD6-62A0-9258-EAF38CA13AE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929E4C-CFCF-1D4A-9D4E-B50FD40B1627}" type="datetimeFigureOut">
              <a:rPr lang="en-US" smtClean="0"/>
              <a:t>7/26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7B0607-A452-D547-B779-7C68979467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9594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Calibri"/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17B0607-A452-D547-B779-7C689794678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5051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DA258D-87C1-5DB6-3C6D-CFC8E582DF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FFC597-0C59-F05A-A5BC-CA5B9B2485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BBAB6C-2F80-25E0-30C4-44D0E9590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5FE26-44A4-AF93-12BB-302EB415EF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FB60AA-835D-4067-C9D5-4B2AECD25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388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FB165-E3DB-04C6-C281-79712ABB0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B659E2-5C35-4576-798B-4C384B0D1F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101B65-CB3A-9251-5AB2-84A000F38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DF81C8-AD1E-DB8A-6D36-C3E32D2BA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614C5B-55DD-0FE0-7A68-03E8DA820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988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30D50A-15E5-95BD-B705-AD09E5A264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A49D41-D98E-3DEF-961F-DA7E3A7A0C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3871D6-7CB2-66D1-D8E5-5B6E8E2F6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AF85A5-ADE3-4AD4-FD29-BE0B6A90A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E6EE3E-0A9D-2339-DF4A-BB1A710C0E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0767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1C0DB-92AC-1F47-F4CD-8536A092D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CCFC11-D262-1488-B7B2-0722970A84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7D63D8-A9B0-615E-84FC-48C967432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493434-F90C-5232-5591-AB9A769A8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5772E1-AB3B-3BFA-3C83-1DAB653E0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5273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7B7660-6B97-7ED6-522C-428D3B7AC1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5C559B1-6858-116A-C577-D977A653D4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B7DD88-F179-81B9-0D01-9B6DCE8B6C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CD1D8-6331-B6AD-BCB8-4EE8E75256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92403-FC90-BD7B-934F-A425508F1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821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58D87-48AD-47E7-1381-DC9203D764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9937EE1-6147-57D4-B22B-7A4DAD0E27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3665E1-F9D7-484F-9DC7-C3FA87299F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EC00E6-B168-B7FA-5BB9-437444621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509697-7AC4-F3D8-F7A6-CB0CE41A4A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EC3EAB-42BC-289D-BB9F-E96566161D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273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BB6DE8-7494-F69F-46A1-132D7FDFE6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96FA09-38F9-4B85-3DE4-12BA988B55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DA67C1-FCF9-52D5-9B1E-9A86AFF350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844FA5-452B-FAFE-7264-229D5A6D9F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0B5F5F-EF20-B796-1533-F5CEA7EBCD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68D8045-1056-7913-FC58-9373B90594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60509D3-B28B-B0B9-EE3E-6C407D3052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8353DB6-311D-5F17-C355-5FB7D80C8B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8313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95FD2E-E191-1EA0-5E0C-388FE9877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F25845-6BD7-E64A-DEE9-BC0D1FF009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830AF19-5E25-BB6C-48EC-777987ECE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A1CA51-0310-377B-DAC0-B643434BD6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58836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751CE5-5EEC-02C4-982D-5D46856BA7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39EE02-7D76-D067-AF1F-0F88CCB35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4EE64F-230F-A8F8-C3B5-7985237BC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2034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69571-6533-30D1-22B8-AF4CB90B5B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BADDFD-D543-E0EF-E439-1C84A7CAC5F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3ACB269-E40D-9BF0-DF65-7C03575F90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19ACB8-C8D5-3C0A-3D53-A0CBD0E4B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815E09-A067-9894-A4FE-C0210BA53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193A4C-B806-B618-3475-9C715D101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1486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0C174-805F-6677-AC00-874D5747F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EA1792-345F-FFB5-3948-8E0FA16725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261680-65BA-0FFE-3968-439C405069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CF6648-16BA-0B40-83F9-4B5535EE2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5B5433-09BA-381A-970D-6D8617BFE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855D1E-637C-A377-366D-0B2E07FABE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416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A5ED788-5979-A31B-DF45-D1CE43ECC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5F6BA5-2C75-7568-A2BC-FCD7109C7C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D33C7F-CDEB-6E82-E2A2-DA2608EBCA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B0EAF89-F3E5-3742-A175-836651DF95C8}" type="datetimeFigureOut">
              <a:rPr lang="en-US" smtClean="0"/>
              <a:t>7/26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AB2B80-2C1F-F3C0-6A57-63B6FC80BD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2E149F-9C93-6ACC-9659-77FEECD60F4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0F7EAAF-DC46-1741-9BE4-1615E646A2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624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FB01BE41-0DD6-62A0-9258-EAF38CA13A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1635457"/>
              </p:ext>
            </p:extLst>
          </p:nvPr>
        </p:nvGraphicFramePr>
        <p:xfrm>
          <a:off x="453887" y="1374559"/>
          <a:ext cx="10515599" cy="361585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022348">
                  <a:extLst>
                    <a:ext uri="{9D8B030D-6E8A-4147-A177-3AD203B41FA5}">
                      <a16:colId xmlns:a16="http://schemas.microsoft.com/office/drawing/2014/main" val="1898038474"/>
                    </a:ext>
                  </a:extLst>
                </a:gridCol>
                <a:gridCol w="1008137">
                  <a:extLst>
                    <a:ext uri="{9D8B030D-6E8A-4147-A177-3AD203B41FA5}">
                      <a16:colId xmlns:a16="http://schemas.microsoft.com/office/drawing/2014/main" val="3053152318"/>
                    </a:ext>
                  </a:extLst>
                </a:gridCol>
                <a:gridCol w="633122">
                  <a:extLst>
                    <a:ext uri="{9D8B030D-6E8A-4147-A177-3AD203B41FA5}">
                      <a16:colId xmlns:a16="http://schemas.microsoft.com/office/drawing/2014/main" val="3018391442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2331269675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3612054368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1107882001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2042317541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2002439084"/>
                    </a:ext>
                  </a:extLst>
                </a:gridCol>
                <a:gridCol w="396271">
                  <a:extLst>
                    <a:ext uri="{9D8B030D-6E8A-4147-A177-3AD203B41FA5}">
                      <a16:colId xmlns:a16="http://schemas.microsoft.com/office/drawing/2014/main" val="599141388"/>
                    </a:ext>
                  </a:extLst>
                </a:gridCol>
                <a:gridCol w="455484">
                  <a:extLst>
                    <a:ext uri="{9D8B030D-6E8A-4147-A177-3AD203B41FA5}">
                      <a16:colId xmlns:a16="http://schemas.microsoft.com/office/drawing/2014/main" val="1586445067"/>
                    </a:ext>
                  </a:extLst>
                </a:gridCol>
                <a:gridCol w="523806">
                  <a:extLst>
                    <a:ext uri="{9D8B030D-6E8A-4147-A177-3AD203B41FA5}">
                      <a16:colId xmlns:a16="http://schemas.microsoft.com/office/drawing/2014/main" val="3883028823"/>
                    </a:ext>
                  </a:extLst>
                </a:gridCol>
                <a:gridCol w="497995">
                  <a:extLst>
                    <a:ext uri="{9D8B030D-6E8A-4147-A177-3AD203B41FA5}">
                      <a16:colId xmlns:a16="http://schemas.microsoft.com/office/drawing/2014/main" val="1864297796"/>
                    </a:ext>
                  </a:extLst>
                </a:gridCol>
                <a:gridCol w="497995">
                  <a:extLst>
                    <a:ext uri="{9D8B030D-6E8A-4147-A177-3AD203B41FA5}">
                      <a16:colId xmlns:a16="http://schemas.microsoft.com/office/drawing/2014/main" val="724956465"/>
                    </a:ext>
                  </a:extLst>
                </a:gridCol>
                <a:gridCol w="455484">
                  <a:extLst>
                    <a:ext uri="{9D8B030D-6E8A-4147-A177-3AD203B41FA5}">
                      <a16:colId xmlns:a16="http://schemas.microsoft.com/office/drawing/2014/main" val="1652818907"/>
                    </a:ext>
                  </a:extLst>
                </a:gridCol>
                <a:gridCol w="497995">
                  <a:extLst>
                    <a:ext uri="{9D8B030D-6E8A-4147-A177-3AD203B41FA5}">
                      <a16:colId xmlns:a16="http://schemas.microsoft.com/office/drawing/2014/main" val="1045165945"/>
                    </a:ext>
                  </a:extLst>
                </a:gridCol>
                <a:gridCol w="497995">
                  <a:extLst>
                    <a:ext uri="{9D8B030D-6E8A-4147-A177-3AD203B41FA5}">
                      <a16:colId xmlns:a16="http://schemas.microsoft.com/office/drawing/2014/main" val="1212156216"/>
                    </a:ext>
                  </a:extLst>
                </a:gridCol>
                <a:gridCol w="523806">
                  <a:extLst>
                    <a:ext uri="{9D8B030D-6E8A-4147-A177-3AD203B41FA5}">
                      <a16:colId xmlns:a16="http://schemas.microsoft.com/office/drawing/2014/main" val="3983675178"/>
                    </a:ext>
                  </a:extLst>
                </a:gridCol>
                <a:gridCol w="523806">
                  <a:extLst>
                    <a:ext uri="{9D8B030D-6E8A-4147-A177-3AD203B41FA5}">
                      <a16:colId xmlns:a16="http://schemas.microsoft.com/office/drawing/2014/main" val="893111359"/>
                    </a:ext>
                  </a:extLst>
                </a:gridCol>
              </a:tblGrid>
              <a:tr h="139884"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Prenol Lipid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LIPID MAPS ID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Peak No.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WTL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KOL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OEL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WTD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KOD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1000" b="1" u="none" strike="noStrike">
                          <a:effectLst/>
                          <a:latin typeface="Times New Roman"/>
                        </a:rPr>
                        <a:t>OED</a:t>
                      </a:r>
                      <a:endParaRPr lang="en-CA" sz="10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WTLxWTD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KOLxKOD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OELxOED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900" b="1" u="none" strike="noStrike">
                          <a:effectLst/>
                          <a:latin typeface="Times New Roman"/>
                        </a:rPr>
                        <a:t>T-Test </a:t>
                      </a:r>
                      <a:endParaRPr lang="en-CA" sz="9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WTLxKOL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WTLxOEL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WTDxKOD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1" u="none" strike="noStrike">
                          <a:effectLst/>
                          <a:latin typeface="Times New Roman"/>
                        </a:rPr>
                        <a:t>WTDxOED</a:t>
                      </a:r>
                      <a:endParaRPr lang="en-CA" sz="7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61395792"/>
                  </a:ext>
                </a:extLst>
              </a:tr>
              <a:tr h="109474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u="none" strike="noStrike">
                          <a:effectLst/>
                          <a:latin typeface="Times New Roman"/>
                        </a:rPr>
                        <a:t>Plausible annotations for higher plants</a:t>
                      </a:r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b="1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significance</a:t>
                      </a:r>
                      <a:endParaRPr lang="en-CA" sz="6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997689408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err="1">
                          <a:effectLst/>
                          <a:latin typeface="Times New Roman"/>
                        </a:rPr>
                        <a:t>Capsorubin</a:t>
                      </a:r>
                      <a:r>
                        <a:rPr lang="en-CA" sz="600" u="none" strike="noStrike">
                          <a:effectLst/>
                          <a:latin typeface="Times New Roman"/>
                        </a:rPr>
                        <a:t>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04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13996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4±0.4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6±0.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1±0.2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5±0.3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4±0.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4±0.4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967372089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err="1">
                          <a:effectLst/>
                          <a:latin typeface="Times New Roman"/>
                        </a:rPr>
                        <a:t>Capsorubin</a:t>
                      </a:r>
                      <a:r>
                        <a:rPr lang="en-CA" sz="600" u="none" strike="noStrike">
                          <a:effectLst/>
                          <a:latin typeface="Times New Roman"/>
                        </a:rPr>
                        <a:t>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04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2145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7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7±0.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±0.1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1±0.8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63±1.2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5±0.9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353349504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Phytoene  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5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9048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1±0.1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6±0.1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5±0.1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9±0.4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7±0.1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8±0.3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-</a:t>
                      </a: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50470798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upeol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613000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n|51918.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6±0.3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4±0.4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1±0.5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7±0.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9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5±0.6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73327668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utein B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030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10405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7.51±1.6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5.1±3.1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7.94±1.9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94±1.6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1±0.4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5±0.2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385183069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Phyto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9385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4±0.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8±0.2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2±0.1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8±0.2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9±0.2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6±0.7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574807253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Phyto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8915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9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8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4±0.1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2±0.4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3±0.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6±0.4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938802189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Plastochromenol-8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202006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6992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8±0.1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6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8±0.1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±0.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8±0.1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4±0.2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17719852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Plastochromenol-8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202006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89766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±0.2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2±0.1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1±0.2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1±0.7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3±0.4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7±0.7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13415999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Plastochromenol-8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202006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9392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±0.0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9±0.1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±0.1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6±0.5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4±0.1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3±0.3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49749467"/>
                  </a:ext>
                </a:extLst>
              </a:tr>
              <a:tr h="109474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u="none" strike="noStrike">
                          <a:effectLst/>
                          <a:latin typeface="Times New Roman"/>
                        </a:rPr>
                        <a:t>Unlikely annotations for higher plants</a:t>
                      </a:r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617798274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8-hydroxycalamenene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333000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109222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6±0.7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5±0.6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4±0.4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2±0.2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7±0.1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44±0.9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141593386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-Hydroxy-3,4-didehydrolycop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1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7774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±0.0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09±0.0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±0.0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1±0.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8±0.0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7±0.1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907303937"/>
                  </a:ext>
                </a:extLst>
              </a:tr>
              <a:tr h="141132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-Hydroxy-3,4-didehydrolycop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1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8313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59±0.0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09±0.0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±0.0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6±0.1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7±0.0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±0.2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00187674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2-methoxyherbertene-1,2-diol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316000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82457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5±0.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5±0.4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1±0.3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1±0.2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8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9±1.0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983156180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2-Hydroxy-1',2'-dihydrotorulene 1',2'-oxid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55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1042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±0.2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45±0.1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44±0.1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1±0.3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4±0.2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3±0.4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718766756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2-Hydroxyechineno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77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5139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8±0.2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7±0.0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4±0.3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53±0.2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45±0.1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1±0.2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21303652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3'-Dehydrolutein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19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5764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±0.0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1±0.1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±0.0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7±0.3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5±0.2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48±0.4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623672838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3'-Dehydrolutein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19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19061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3.37±0.4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2.41±0.5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2.69±0.8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1±0.4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6±0.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7±0.3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50629353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C25 Monocyclic highly branched isoprenoid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502000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n|53039.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3±0.4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2±0.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7±0.5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5±0.3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8±0.3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3±0.1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334448956"/>
                  </a:ext>
                </a:extLst>
              </a:tr>
              <a:tr h="109474">
                <a:tc>
                  <a:txBody>
                    <a:bodyPr/>
                    <a:lstStyle/>
                    <a:p>
                      <a:pPr algn="l" fontAlgn="b"/>
                      <a:r>
                        <a:rPr lang="en-CA" sz="800" b="1" u="none" strike="noStrike">
                          <a:effectLst/>
                          <a:latin typeface="Times New Roman"/>
                        </a:rPr>
                        <a:t>Uncertain annotations for higher plants</a:t>
                      </a:r>
                      <a:endParaRPr lang="en-CA" sz="800" b="1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440061023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16-Gammaceren-3beta-ol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622000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n|51602.0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9±0.5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84±0.6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63±0.6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2±0.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5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1.27±0.63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23485858"/>
                  </a:ext>
                </a:extLst>
              </a:tr>
              <a:tr h="175159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5</a:t>
                      </a:r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',6'-Epoxy-3'-hydroxy-3-methoxy-4,5-didehydro-5',6'-dihydro-4,6-cyclo-5,6-seco-beta,beta-caroten-5-one  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88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62514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3±0.4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6±0.1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8±0.4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6±0.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7±0.3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0.67±0.6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3726903599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4'-apo-beta-carotenal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9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60685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57±0.3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9±0.0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1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7±0.2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7±0.0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0.85±0.25</a:t>
                      </a:r>
                      <a:endParaRPr lang="en-CA" sz="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639707445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3,4-Didehydro-beta-carot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02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73653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3±0.0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24±0.0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19±0.0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94±2.0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5±0.8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2.48±1.47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913582660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9'-Hydroxy-9'-apo-epsilon,psi-caroten-3-o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60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2358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3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3±0.0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9±0.0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3±0.3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5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3±0.1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363726116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9',10'-Dihydro-beta-zeacarotene-3,17'-diol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52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89455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3±0.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3±0.1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6±0.2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9±0.5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2±0.3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±0.6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4280466942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 dirty="0" err="1">
                          <a:effectLst/>
                          <a:latin typeface="Times New Roman"/>
                        </a:rPr>
                        <a:t>Phytofluene</a:t>
                      </a:r>
                      <a:r>
                        <a:rPr lang="en-CA" sz="600" u="none" strike="noStrike" dirty="0">
                          <a:effectLst/>
                          <a:latin typeface="Times New Roman"/>
                        </a:rPr>
                        <a:t>  </a:t>
                      </a:r>
                      <a:endParaRPr lang="en-CA" sz="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99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9109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8±0.0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8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64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1±0.28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79±0.1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97±0.3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1016965118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ycopenal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47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86185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46±0.0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4±0.1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0.38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38±0.6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3±0.2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5±0.54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*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2781630813"/>
                  </a:ext>
                </a:extLst>
              </a:tr>
              <a:tr h="97310"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OH-Demethylspheroidene  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LMPR01070213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A" sz="500" u="none" strike="noStrike">
                          <a:effectLst/>
                          <a:latin typeface="Times New Roman"/>
                        </a:rPr>
                        <a:t>69539</a:t>
                      </a:r>
                      <a:endParaRPr lang="en-CA" sz="5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9±0.2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5±0.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±0.25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26±0.47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05±0.31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CA" sz="600" u="none" strike="noStrike">
                          <a:effectLst/>
                          <a:latin typeface="Times New Roman"/>
                        </a:rPr>
                        <a:t>1.14±0.36</a:t>
                      </a:r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l" fontAlgn="b"/>
                      <a:endParaRPr lang="en-CA" sz="6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CA" sz="700" u="none" strike="noStrike" dirty="0">
                          <a:effectLst/>
                          <a:latin typeface="Times New Roman"/>
                        </a:rPr>
                        <a:t>-</a:t>
                      </a:r>
                      <a:endParaRPr lang="en-CA" sz="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/>
                      </a:endParaRPr>
                    </a:p>
                  </a:txBody>
                  <a:tcPr marL="0" marR="0" marT="0" marB="0" anchor="b"/>
                </a:tc>
                <a:extLst>
                  <a:ext uri="{0D108BD9-81ED-4DB2-BD59-A6C34878D82A}">
                    <a16:rowId xmlns:a16="http://schemas.microsoft.com/office/drawing/2014/main" val="97132448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E6A9117-5B24-826F-F47B-567E9BB093B6}"/>
              </a:ext>
            </a:extLst>
          </p:cNvPr>
          <p:cNvSpPr txBox="1"/>
          <p:nvPr/>
        </p:nvSpPr>
        <p:spPr>
          <a:xfrm>
            <a:off x="453886" y="159668"/>
            <a:ext cx="10515599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Supplemental Table S1.</a:t>
            </a:r>
            <a:r>
              <a:rPr lang="en-US" sz="1200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Annotated </a:t>
            </a:r>
            <a:r>
              <a:rPr lang="en-US" sz="1200" b="1" kern="100" dirty="0" err="1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prenol</a:t>
            </a:r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 lipid species and their intensities (</a:t>
            </a:r>
            <a:r>
              <a:rPr lang="en-US" sz="1200" b="1" kern="100" dirty="0">
                <a:effectLst/>
                <a:latin typeface="Symbol" pitchFamily="2" charset="2"/>
                <a:ea typeface="Symbol" pitchFamily="2" charset="2"/>
                <a:cs typeface="Symbol" pitchFamily="2" charset="2"/>
              </a:rPr>
              <a:t>±</a:t>
            </a:r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 standard deviation) found in the </a:t>
            </a:r>
            <a:r>
              <a:rPr lang="en-US" sz="1200" b="1" i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Arabidopsis </a:t>
            </a:r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rosette tissue using untargeted </a:t>
            </a:r>
            <a:r>
              <a:rPr lang="en-US" sz="1200" b="1" kern="100" dirty="0" err="1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lipidomics</a:t>
            </a:r>
            <a:r>
              <a:rPr lang="en-US" sz="1200" b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. </a:t>
            </a:r>
            <a:r>
              <a:rPr lang="en-US" sz="1200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Data are shown for wild-type (WT), SLP1 knockout (</a:t>
            </a:r>
            <a:r>
              <a:rPr lang="en-CA" sz="1200" i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slp1-/-</a:t>
            </a:r>
            <a:r>
              <a:rPr lang="en-CA" sz="1200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, KO), and over-expression (OE) lines harvested under light (L) and dark (D) conditions. Lipids are sorted by likelihood of </a:t>
            </a:r>
            <a:r>
              <a:rPr lang="en-US" sz="1200" i="1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bona fide</a:t>
            </a:r>
            <a:r>
              <a:rPr lang="en-US" sz="1200" kern="100" dirty="0">
                <a:effectLst/>
                <a:latin typeface="Times" pitchFamily="2" charset="0"/>
                <a:ea typeface="Aptos" panose="020B0004020202020204" pitchFamily="34" charset="0"/>
                <a:cs typeface="Times New Roman" panose="02020603050405020304" pitchFamily="18" charset="0"/>
              </a:rPr>
              <a:t> identification in Arabidopsis. Peak numbers correspond to annotations listed in Supplemental Data 1. The right-hand side of the table shows the results of Student’s t-tests comparing light vs. dark (left three columns) and WT vs. SLP1 mutants (right four columns). p &lt; 0.05; *p &lt; 0.01.</a:t>
            </a:r>
            <a:endParaRPr lang="en-CA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CA" sz="12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2349094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663</Words>
  <Application>Microsoft Macintosh PowerPoint</Application>
  <PresentationFormat>Widescreen</PresentationFormat>
  <Paragraphs>47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Aptos</vt:lpstr>
      <vt:lpstr>Aptos Display</vt:lpstr>
      <vt:lpstr>Arial</vt:lpstr>
      <vt:lpstr>Calibri</vt:lpstr>
      <vt:lpstr>Symbol</vt:lpstr>
      <vt:lpstr>Times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 White-Gloria</dc:creator>
  <cp:lastModifiedBy>Gregory Moorhead</cp:lastModifiedBy>
  <cp:revision>11</cp:revision>
  <dcterms:created xsi:type="dcterms:W3CDTF">2025-05-07T21:25:09Z</dcterms:created>
  <dcterms:modified xsi:type="dcterms:W3CDTF">2025-07-26T18:09:53Z</dcterms:modified>
</cp:coreProperties>
</file>